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 snapToGrid="0">
      <p:cViewPr varScale="1">
        <p:scale>
          <a:sx n="113" d="100"/>
          <a:sy n="113" d="100"/>
        </p:scale>
        <p:origin x="39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36A42-061E-4FCD-B782-185B66917D82}" type="datetimeFigureOut">
              <a:rPr lang="zh-CN" altLang="en-US" smtClean="0"/>
              <a:t>2017/11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E852B-CBDF-4851-9773-95EEF22562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42600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36A42-061E-4FCD-B782-185B66917D82}" type="datetimeFigureOut">
              <a:rPr lang="zh-CN" altLang="en-US" smtClean="0"/>
              <a:t>2017/11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E852B-CBDF-4851-9773-95EEF22562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59537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36A42-061E-4FCD-B782-185B66917D82}" type="datetimeFigureOut">
              <a:rPr lang="zh-CN" altLang="en-US" smtClean="0"/>
              <a:t>2017/11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E852B-CBDF-4851-9773-95EEF22562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901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36A42-061E-4FCD-B782-185B66917D82}" type="datetimeFigureOut">
              <a:rPr lang="zh-CN" altLang="en-US" smtClean="0"/>
              <a:t>2017/11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E852B-CBDF-4851-9773-95EEF22562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78638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36A42-061E-4FCD-B782-185B66917D82}" type="datetimeFigureOut">
              <a:rPr lang="zh-CN" altLang="en-US" smtClean="0"/>
              <a:t>2017/11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E852B-CBDF-4851-9773-95EEF22562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4403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36A42-061E-4FCD-B782-185B66917D82}" type="datetimeFigureOut">
              <a:rPr lang="zh-CN" altLang="en-US" smtClean="0"/>
              <a:t>2017/11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E852B-CBDF-4851-9773-95EEF22562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28971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36A42-061E-4FCD-B782-185B66917D82}" type="datetimeFigureOut">
              <a:rPr lang="zh-CN" altLang="en-US" smtClean="0"/>
              <a:t>2017/11/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E852B-CBDF-4851-9773-95EEF22562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15460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36A42-061E-4FCD-B782-185B66917D82}" type="datetimeFigureOut">
              <a:rPr lang="zh-CN" altLang="en-US" smtClean="0"/>
              <a:t>2017/11/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E852B-CBDF-4851-9773-95EEF22562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40274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36A42-061E-4FCD-B782-185B66917D82}" type="datetimeFigureOut">
              <a:rPr lang="zh-CN" altLang="en-US" smtClean="0"/>
              <a:t>2017/11/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E852B-CBDF-4851-9773-95EEF22562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15612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36A42-061E-4FCD-B782-185B66917D82}" type="datetimeFigureOut">
              <a:rPr lang="zh-CN" altLang="en-US" smtClean="0"/>
              <a:t>2017/11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E852B-CBDF-4851-9773-95EEF22562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50632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36A42-061E-4FCD-B782-185B66917D82}" type="datetimeFigureOut">
              <a:rPr lang="zh-CN" altLang="en-US" smtClean="0"/>
              <a:t>2017/11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E852B-CBDF-4851-9773-95EEF22562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04392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036A42-061E-4FCD-B782-185B66917D82}" type="datetimeFigureOut">
              <a:rPr lang="zh-CN" altLang="en-US" smtClean="0"/>
              <a:t>2017/11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5E852B-CBDF-4851-9773-95EEF22562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599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tiff"/><Relationship Id="rId3" Type="http://schemas.openxmlformats.org/officeDocument/2006/relationships/image" Target="../media/image3.tiff"/><Relationship Id="rId7" Type="http://schemas.openxmlformats.org/officeDocument/2006/relationships/image" Target="../media/image7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tiff"/><Relationship Id="rId11" Type="http://schemas.openxmlformats.org/officeDocument/2006/relationships/image" Target="../media/image11.tiff"/><Relationship Id="rId5" Type="http://schemas.openxmlformats.org/officeDocument/2006/relationships/image" Target="../media/image5.tiff"/><Relationship Id="rId10" Type="http://schemas.openxmlformats.org/officeDocument/2006/relationships/image" Target="../media/image10.tiff"/><Relationship Id="rId4" Type="http://schemas.openxmlformats.org/officeDocument/2006/relationships/image" Target="../media/image4.tiff"/><Relationship Id="rId9" Type="http://schemas.openxmlformats.org/officeDocument/2006/relationships/image" Target="../media/image9.tif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1875637" y="257578"/>
            <a:ext cx="333172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/>
              <a:t>Supplementary Figure s1</a:t>
            </a:r>
            <a:endParaRPr lang="zh-CN" altLang="en-US" sz="2000" b="1" dirty="0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15260" y="1531620"/>
            <a:ext cx="6480000" cy="39893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035435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图片 1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62913" y="3280329"/>
            <a:ext cx="2297288" cy="1080000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5534" y="674693"/>
            <a:ext cx="5220000" cy="5950488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0" y="-17366"/>
            <a:ext cx="42203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/>
              <a:t>Supplementary Figure S2</a:t>
            </a:r>
            <a:endParaRPr lang="zh-CN" altLang="en-US" sz="2000" b="1" dirty="0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063" y="745502"/>
            <a:ext cx="2903273" cy="144000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140344" y="447383"/>
            <a:ext cx="29633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a</a:t>
            </a:r>
            <a:endParaRPr lang="zh-CN" altLang="en-US" sz="2400" b="1" dirty="0"/>
          </a:p>
        </p:txBody>
      </p:sp>
      <p:sp>
        <p:nvSpPr>
          <p:cNvPr id="8" name="文本框 7"/>
          <p:cNvSpPr txBox="1"/>
          <p:nvPr/>
        </p:nvSpPr>
        <p:spPr>
          <a:xfrm>
            <a:off x="3576892" y="443861"/>
            <a:ext cx="29633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b</a:t>
            </a:r>
            <a:endParaRPr lang="zh-CN" altLang="en-US" sz="2400" b="1" dirty="0"/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346" y="3780161"/>
            <a:ext cx="3092364" cy="1440000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346" y="2290875"/>
            <a:ext cx="2914909" cy="1440000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466" y="5273277"/>
            <a:ext cx="2883051" cy="144000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66809" y="57653"/>
            <a:ext cx="1407143" cy="900000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80568" y="2317413"/>
            <a:ext cx="1622289" cy="1080000"/>
          </a:xfrm>
          <a:prstGeom prst="rect">
            <a:avLst/>
          </a:prstGeom>
        </p:spPr>
      </p:pic>
      <p:sp>
        <p:nvSpPr>
          <p:cNvPr id="15" name="文本框 14"/>
          <p:cNvSpPr txBox="1"/>
          <p:nvPr/>
        </p:nvSpPr>
        <p:spPr>
          <a:xfrm>
            <a:off x="9197607" y="57653"/>
            <a:ext cx="296333" cy="52629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/>
              <a:t>c</a:t>
            </a:r>
            <a:endParaRPr lang="en-US" altLang="zh-CN" sz="2400" b="1" dirty="0"/>
          </a:p>
          <a:p>
            <a:endParaRPr lang="en-US" altLang="zh-CN" sz="2400" b="1" dirty="0" smtClean="0"/>
          </a:p>
          <a:p>
            <a:endParaRPr lang="en-US" altLang="zh-CN" sz="2400" b="1" dirty="0" smtClean="0"/>
          </a:p>
          <a:p>
            <a:r>
              <a:rPr lang="en-US" altLang="zh-CN" sz="2400" b="1" dirty="0" smtClean="0"/>
              <a:t>d</a:t>
            </a:r>
          </a:p>
          <a:p>
            <a:endParaRPr lang="en-US" altLang="zh-CN" sz="2400" b="1" dirty="0"/>
          </a:p>
          <a:p>
            <a:endParaRPr lang="en-US" altLang="zh-CN" sz="2400" b="1" dirty="0" smtClean="0"/>
          </a:p>
          <a:p>
            <a:r>
              <a:rPr lang="en-US" altLang="zh-CN" sz="2400" b="1" dirty="0" smtClean="0"/>
              <a:t>e</a:t>
            </a:r>
          </a:p>
          <a:p>
            <a:endParaRPr lang="en-US" altLang="zh-CN" sz="2400" b="1" dirty="0"/>
          </a:p>
          <a:p>
            <a:endParaRPr lang="en-US" altLang="zh-CN" sz="2400" b="1" dirty="0" smtClean="0"/>
          </a:p>
          <a:p>
            <a:endParaRPr lang="en-US" altLang="zh-CN" sz="2400" b="1" dirty="0"/>
          </a:p>
          <a:p>
            <a:endParaRPr lang="en-US" altLang="zh-CN" sz="2400" b="1" dirty="0" smtClean="0"/>
          </a:p>
          <a:p>
            <a:endParaRPr lang="en-US" altLang="zh-CN" sz="2400" b="1" dirty="0"/>
          </a:p>
          <a:p>
            <a:r>
              <a:rPr lang="en-US" altLang="zh-CN" sz="2400" b="1" dirty="0" smtClean="0"/>
              <a:t>f</a:t>
            </a:r>
            <a:endParaRPr lang="en-US" altLang="zh-CN" sz="2400" b="1" dirty="0"/>
          </a:p>
          <a:p>
            <a:endParaRPr lang="zh-CN" altLang="en-US" sz="2400" b="1" dirty="0"/>
          </a:p>
        </p:txBody>
      </p:sp>
      <p:pic>
        <p:nvPicPr>
          <p:cNvPr id="21" name="图片 20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55167" y="939985"/>
            <a:ext cx="2340000" cy="137743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29392" y="4496866"/>
            <a:ext cx="2127437" cy="23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304580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524000" y="0"/>
            <a:ext cx="383936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/>
              <a:t>Supplementary</a:t>
            </a:r>
          </a:p>
          <a:p>
            <a:r>
              <a:rPr lang="en-US" altLang="zh-CN" sz="2000" b="1" dirty="0"/>
              <a:t>  Figure S3</a:t>
            </a:r>
            <a:endParaRPr lang="zh-CN" altLang="en-US" sz="2000" b="1" dirty="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4553" y="0"/>
            <a:ext cx="5142895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778107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8363" y="1985645"/>
            <a:ext cx="8280000" cy="2335047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2365034" y="1223493"/>
            <a:ext cx="54309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/>
              <a:t>Supplementary Figure S4</a:t>
            </a:r>
            <a:endParaRPr lang="zh-CN" alt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24040547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414867" y="223712"/>
            <a:ext cx="411515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Supplementary  Figure </a:t>
            </a:r>
            <a:r>
              <a:rPr lang="en-US" altLang="zh-CN" sz="2000" b="1" dirty="0"/>
              <a:t>S5</a:t>
            </a:r>
            <a:endParaRPr lang="zh-CN" altLang="en-US" sz="2000" b="1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34365" y="0"/>
            <a:ext cx="470633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6560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26969" y="1731629"/>
            <a:ext cx="6098597" cy="3880925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2365034" y="528034"/>
            <a:ext cx="54309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/>
              <a:t>Supplementary Figure S6</a:t>
            </a:r>
            <a:endParaRPr lang="zh-CN" alt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10074301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0097" y="1626623"/>
            <a:ext cx="6870062" cy="3898413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2365034" y="528034"/>
            <a:ext cx="54309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/>
              <a:t>Supplementary Figure S7</a:t>
            </a:r>
            <a:endParaRPr lang="zh-CN" alt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3595066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9</TotalTime>
  <Words>28</Words>
  <Application>Microsoft Office PowerPoint</Application>
  <PresentationFormat>宽屏</PresentationFormat>
  <Paragraphs>23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2" baseType="lpstr"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Sky123.Org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nna li</dc:creator>
  <cp:lastModifiedBy>linna li</cp:lastModifiedBy>
  <cp:revision>30</cp:revision>
  <dcterms:created xsi:type="dcterms:W3CDTF">2017-04-25T10:21:25Z</dcterms:created>
  <dcterms:modified xsi:type="dcterms:W3CDTF">2017-11-01T02:27:59Z</dcterms:modified>
</cp:coreProperties>
</file>